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4" r:id="rId3"/>
    <p:sldId id="265" r:id="rId4"/>
    <p:sldId id="257" r:id="rId5"/>
    <p:sldId id="259" r:id="rId6"/>
    <p:sldId id="260" r:id="rId7"/>
    <p:sldId id="261" r:id="rId8"/>
    <p:sldId id="262" r:id="rId9"/>
    <p:sldId id="26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00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986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829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499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599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769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065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162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961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74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105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ABDE6-50A0-40DF-86CD-45054059C355}" type="datetimeFigureOut">
              <a:rPr lang="en-US" smtClean="0"/>
              <a:t>22-Sep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B55B7-570B-486B-ADE6-29161151E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380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RDBP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85395"/>
            <a:ext cx="10515600" cy="3631798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 flipV="1">
            <a:off x="2382982" y="4922983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003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PK1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93556"/>
            <a:ext cx="10515600" cy="3615475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364510" y="4922983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8791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R3C1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80377"/>
            <a:ext cx="10515600" cy="3641834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355274" y="4922983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04891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ME2</a:t>
            </a: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10401"/>
            <a:ext cx="10515600" cy="3781786"/>
          </a:xfrm>
          <a:prstGeom prst="rect">
            <a:avLst/>
          </a:prstGeom>
        </p:spPr>
      </p:pic>
      <p:cxnSp>
        <p:nvCxnSpPr>
          <p:cNvPr id="7" name="Straight Connector 6"/>
          <p:cNvCxnSpPr/>
          <p:nvPr/>
        </p:nvCxnSpPr>
        <p:spPr>
          <a:xfrm flipV="1">
            <a:off x="2604655" y="4719781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51326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TE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21208"/>
            <a:ext cx="10515600" cy="3760172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549239" y="4765961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88055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DKN1B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01316"/>
            <a:ext cx="10515600" cy="3799955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623127" y="4719781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8909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XRA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33182"/>
            <a:ext cx="10515600" cy="3736224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623127" y="4747489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14561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XTR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088633"/>
            <a:ext cx="10515600" cy="3825321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641599" y="4738253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61036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DK4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126079"/>
            <a:ext cx="10515600" cy="3750430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V="1">
            <a:off x="2623127" y="4747489"/>
            <a:ext cx="286327" cy="39716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2408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9</Words>
  <Application>Microsoft Office PowerPoint</Application>
  <PresentationFormat>Widescreen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TARDBP</vt:lpstr>
      <vt:lpstr>MAPK1</vt:lpstr>
      <vt:lpstr>NR3C1</vt:lpstr>
      <vt:lpstr>NME2</vt:lpstr>
      <vt:lpstr>PTEN</vt:lpstr>
      <vt:lpstr>CDKN1B</vt:lpstr>
      <vt:lpstr>RXRA</vt:lpstr>
      <vt:lpstr>OXTR</vt:lpstr>
      <vt:lpstr>CDK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ME2</dc:title>
  <dc:creator>Administrator</dc:creator>
  <cp:lastModifiedBy>Ghada Mohammed</cp:lastModifiedBy>
  <cp:revision>6</cp:revision>
  <dcterms:created xsi:type="dcterms:W3CDTF">2021-09-17T06:13:07Z</dcterms:created>
  <dcterms:modified xsi:type="dcterms:W3CDTF">2021-09-22T06:22:50Z</dcterms:modified>
</cp:coreProperties>
</file>